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429" r:id="rId2"/>
    <p:sldId id="431" r:id="rId3"/>
  </p:sldIdLst>
  <p:sldSz cx="12192000" cy="6858000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6" d="100"/>
          <a:sy n="66" d="100"/>
        </p:scale>
        <p:origin x="668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4763" y="0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0F9A77F-85E6-4F85-9689-443D996704DF}" type="datetimeFigureOut">
              <a:rPr kumimoji="1" lang="ja-JP" altLang="en-US" smtClean="0"/>
              <a:t>2025/1/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09575" y="1233488"/>
            <a:ext cx="5916613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100" y="4748213"/>
            <a:ext cx="5389563" cy="38846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013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4763" y="9371013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D62B67-6D30-454E-B65B-925066150C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6348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FD62B67-6D30-454E-B65B-925066150C15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675502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6AD2320-67B7-635D-2FA4-CF018868CD6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361D2DA5-3DF8-3C30-07B6-7E8D3765CB7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11" indent="0" algn="ctr">
              <a:buNone/>
              <a:defRPr sz="2000"/>
            </a:lvl2pPr>
            <a:lvl3pPr marL="914422" indent="0" algn="ctr">
              <a:buNone/>
              <a:defRPr sz="1801"/>
            </a:lvl3pPr>
            <a:lvl4pPr marL="1371635" indent="0" algn="ctr">
              <a:buNone/>
              <a:defRPr sz="1600"/>
            </a:lvl4pPr>
            <a:lvl5pPr marL="1828846" indent="0" algn="ctr">
              <a:buNone/>
              <a:defRPr sz="1600"/>
            </a:lvl5pPr>
            <a:lvl6pPr marL="2286057" indent="0" algn="ctr">
              <a:buNone/>
              <a:defRPr sz="1600"/>
            </a:lvl6pPr>
            <a:lvl7pPr marL="2743268" indent="0" algn="ctr">
              <a:buNone/>
              <a:defRPr sz="1600"/>
            </a:lvl7pPr>
            <a:lvl8pPr marL="3200481" indent="0" algn="ctr">
              <a:buNone/>
              <a:defRPr sz="1600"/>
            </a:lvl8pPr>
            <a:lvl9pPr marL="3657692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A0BA099-1B25-58D2-564E-5BE3090EBB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0B823C-C00A-44F4-9664-6E4112EDF4BF}" type="datetimeFigureOut">
              <a:rPr kumimoji="1" lang="ja-JP" altLang="en-US" smtClean="0"/>
              <a:t>2025/1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892B6E6-E553-2FE1-EE1B-3690869AB6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6758334-2004-D989-483D-C002552674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254EE4-857C-495E-ACE1-2787790E99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72432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F16D4F7-A4E3-4431-FD66-E312ADF728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A5277EB-40FD-69C6-12F1-D772FE9912E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A58430D-CCD0-2283-8822-80040608D5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0B823C-C00A-44F4-9664-6E4112EDF4BF}" type="datetimeFigureOut">
              <a:rPr kumimoji="1" lang="ja-JP" altLang="en-US" smtClean="0"/>
              <a:t>2025/1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773AA3C-5024-780E-7B29-256BA83350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48AB7D7-E702-D222-685F-110C37C81A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254EE4-857C-495E-ACE1-2787790E99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17434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EE56B20E-FCD0-FAED-0CB3-04C34D8F83C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298FE41-4DCA-192C-D7C2-06F80377070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E60BAD3-3132-2A82-AA5E-AF03AAD473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0B823C-C00A-44F4-9664-6E4112EDF4BF}" type="datetimeFigureOut">
              <a:rPr kumimoji="1" lang="ja-JP" altLang="en-US" smtClean="0"/>
              <a:t>2025/1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21C0039-3CB1-D290-703A-1AC545E558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1EF2A3E-1076-4B95-70A0-B7FAF34659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254EE4-857C-495E-ACE1-2787790E99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21734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DC6E83E-EC65-3FAA-137E-BA9D87BFA0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56941BC-D393-A536-FC33-EC95F2B40CD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3AA69D4-2895-6145-20C1-6944F8CB48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0B823C-C00A-44F4-9664-6E4112EDF4BF}" type="datetimeFigureOut">
              <a:rPr kumimoji="1" lang="ja-JP" altLang="en-US" smtClean="0"/>
              <a:t>2025/1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E2FABCB-5DBF-0FEC-D931-BAB17A74C1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7C170D1-F752-ED5E-4935-6078CD4F4C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254EE4-857C-495E-ACE1-2787790E99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31490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7582858-0BDA-47B9-0C48-E885332E6C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3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782F522-038B-61FB-56E0-847D44D1FB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3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11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22" indent="0">
              <a:buNone/>
              <a:defRPr sz="1801">
                <a:solidFill>
                  <a:schemeClr val="tx1">
                    <a:tint val="75000"/>
                  </a:schemeClr>
                </a:solidFill>
              </a:defRPr>
            </a:lvl3pPr>
            <a:lvl4pPr marL="137163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5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6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8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9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22B23A4-9EFB-A481-0241-909A48F082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0B823C-C00A-44F4-9664-6E4112EDF4BF}" type="datetimeFigureOut">
              <a:rPr kumimoji="1" lang="ja-JP" altLang="en-US" smtClean="0"/>
              <a:t>2025/1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08639B2-67BC-0A60-8A2B-20224481DF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326D578-981C-88B4-B307-65AD2C5CB4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254EE4-857C-495E-ACE1-2787790E99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3027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69F1D3F-BFB1-3FCD-2CD8-E2C8A76CA6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CC03000-08B5-BA3D-069E-D3EAE2F8C37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D812154-7126-2B10-73C5-2464B3BA7DD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D0C98DE-4C8A-6F70-E793-C4DB003929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0B823C-C00A-44F4-9664-6E4112EDF4BF}" type="datetimeFigureOut">
              <a:rPr kumimoji="1" lang="ja-JP" altLang="en-US" smtClean="0"/>
              <a:t>2025/1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DC1621F-49C3-913B-F9E8-A9481A6054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41DF84C-8AA9-EA88-8DE3-2A581B54DF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254EE4-857C-495E-ACE1-2787790E99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97936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0F1FB5E-DC17-F833-09FB-7EB87167E0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365127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8F15074-5149-CD4C-F43E-65733648F2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91" y="1681164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11" indent="0">
              <a:buNone/>
              <a:defRPr sz="2000" b="1"/>
            </a:lvl2pPr>
            <a:lvl3pPr marL="914422" indent="0">
              <a:buNone/>
              <a:defRPr sz="1801" b="1"/>
            </a:lvl3pPr>
            <a:lvl4pPr marL="1371635" indent="0">
              <a:buNone/>
              <a:defRPr sz="1600" b="1"/>
            </a:lvl4pPr>
            <a:lvl5pPr marL="1828846" indent="0">
              <a:buNone/>
              <a:defRPr sz="1600" b="1"/>
            </a:lvl5pPr>
            <a:lvl6pPr marL="2286057" indent="0">
              <a:buNone/>
              <a:defRPr sz="1600" b="1"/>
            </a:lvl6pPr>
            <a:lvl7pPr marL="2743268" indent="0">
              <a:buNone/>
              <a:defRPr sz="1600" b="1"/>
            </a:lvl7pPr>
            <a:lvl8pPr marL="3200481" indent="0">
              <a:buNone/>
              <a:defRPr sz="1600" b="1"/>
            </a:lvl8pPr>
            <a:lvl9pPr marL="3657692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4D17AE3-5485-E718-2A22-0CEB7C66D92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91" y="2505076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2A18FB89-8D0A-843F-6FA0-15A975297CE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3" y="1681164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11" indent="0">
              <a:buNone/>
              <a:defRPr sz="2000" b="1"/>
            </a:lvl2pPr>
            <a:lvl3pPr marL="914422" indent="0">
              <a:buNone/>
              <a:defRPr sz="1801" b="1"/>
            </a:lvl3pPr>
            <a:lvl4pPr marL="1371635" indent="0">
              <a:buNone/>
              <a:defRPr sz="1600" b="1"/>
            </a:lvl4pPr>
            <a:lvl5pPr marL="1828846" indent="0">
              <a:buNone/>
              <a:defRPr sz="1600" b="1"/>
            </a:lvl5pPr>
            <a:lvl6pPr marL="2286057" indent="0">
              <a:buNone/>
              <a:defRPr sz="1600" b="1"/>
            </a:lvl6pPr>
            <a:lvl7pPr marL="2743268" indent="0">
              <a:buNone/>
              <a:defRPr sz="1600" b="1"/>
            </a:lvl7pPr>
            <a:lvl8pPr marL="3200481" indent="0">
              <a:buNone/>
              <a:defRPr sz="1600" b="1"/>
            </a:lvl8pPr>
            <a:lvl9pPr marL="3657692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85CC98F6-D7D8-01BD-D1EB-16A4BF54273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3" y="2505076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EE30BDA2-185A-FC62-A66B-638459710C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0B823C-C00A-44F4-9664-6E4112EDF4BF}" type="datetimeFigureOut">
              <a:rPr kumimoji="1" lang="ja-JP" altLang="en-US" smtClean="0"/>
              <a:t>2025/1/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74126CE3-2B09-850F-4F29-F741EE24AA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BC2C23CB-160E-475E-3404-7E068AAA58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254EE4-857C-495E-ACE1-2787790E99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0300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D1722D9-FA41-0041-8D1E-0DC031B767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3789EC21-EECC-DF9A-9BF6-FDACE14B58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0B823C-C00A-44F4-9664-6E4112EDF4BF}" type="datetimeFigureOut">
              <a:rPr kumimoji="1" lang="ja-JP" altLang="en-US" smtClean="0"/>
              <a:t>2025/1/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3BF854A8-DA49-6FA4-F8A4-8EB8C9DEAD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112673E6-03A4-E478-5022-EC207481F8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254EE4-857C-495E-ACE1-2787790E99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160221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C5317331-3273-1CFB-B9F2-B2B839A928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0B823C-C00A-44F4-9664-6E4112EDF4BF}" type="datetimeFigureOut">
              <a:rPr kumimoji="1" lang="ja-JP" altLang="en-US" smtClean="0"/>
              <a:t>2025/1/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0F88B678-841C-1C28-5635-0039CCD4E6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486D87E6-75C1-89F5-B4BA-32CABEDA2A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254EE4-857C-495E-ACE1-2787790E99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81122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441CA78-1C80-8994-7BA8-24FFB082CE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1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5E61E5D-6034-45CD-4210-F6DBF7E7C1E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90" y="987427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AF75BFBC-487C-A755-EBEF-B8E0DFCAE2E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1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11" indent="0">
              <a:buNone/>
              <a:defRPr sz="1401"/>
            </a:lvl2pPr>
            <a:lvl3pPr marL="914422" indent="0">
              <a:buNone/>
              <a:defRPr sz="1200"/>
            </a:lvl3pPr>
            <a:lvl4pPr marL="1371635" indent="0">
              <a:buNone/>
              <a:defRPr sz="1001"/>
            </a:lvl4pPr>
            <a:lvl5pPr marL="1828846" indent="0">
              <a:buNone/>
              <a:defRPr sz="1001"/>
            </a:lvl5pPr>
            <a:lvl6pPr marL="2286057" indent="0">
              <a:buNone/>
              <a:defRPr sz="1001"/>
            </a:lvl6pPr>
            <a:lvl7pPr marL="2743268" indent="0">
              <a:buNone/>
              <a:defRPr sz="1001"/>
            </a:lvl7pPr>
            <a:lvl8pPr marL="3200481" indent="0">
              <a:buNone/>
              <a:defRPr sz="1001"/>
            </a:lvl8pPr>
            <a:lvl9pPr marL="3657692" indent="0">
              <a:buNone/>
              <a:defRPr sz="100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4411F95-5EDB-6595-496D-A1666EFCDB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0B823C-C00A-44F4-9664-6E4112EDF4BF}" type="datetimeFigureOut">
              <a:rPr kumimoji="1" lang="ja-JP" altLang="en-US" smtClean="0"/>
              <a:t>2025/1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DF55F7E-66E1-8F36-752B-AF8D960F01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2FDA9CF-C40F-97A5-E157-DAC8CFD7A8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254EE4-857C-495E-ACE1-2787790E99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52879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2F82781-E7D6-29BB-BB08-F83E9D6745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1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AB018EA4-58D2-F8E9-0AB6-A91E6641EB6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90" y="987427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11" indent="0">
              <a:buNone/>
              <a:defRPr sz="2800"/>
            </a:lvl2pPr>
            <a:lvl3pPr marL="914422" indent="0">
              <a:buNone/>
              <a:defRPr sz="2400"/>
            </a:lvl3pPr>
            <a:lvl4pPr marL="1371635" indent="0">
              <a:buNone/>
              <a:defRPr sz="2000"/>
            </a:lvl4pPr>
            <a:lvl5pPr marL="1828846" indent="0">
              <a:buNone/>
              <a:defRPr sz="2000"/>
            </a:lvl5pPr>
            <a:lvl6pPr marL="2286057" indent="0">
              <a:buNone/>
              <a:defRPr sz="2000"/>
            </a:lvl6pPr>
            <a:lvl7pPr marL="2743268" indent="0">
              <a:buNone/>
              <a:defRPr sz="2000"/>
            </a:lvl7pPr>
            <a:lvl8pPr marL="3200481" indent="0">
              <a:buNone/>
              <a:defRPr sz="2000"/>
            </a:lvl8pPr>
            <a:lvl9pPr marL="3657692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0D09F24-DF85-825E-F699-9799E5047D2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1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11" indent="0">
              <a:buNone/>
              <a:defRPr sz="1401"/>
            </a:lvl2pPr>
            <a:lvl3pPr marL="914422" indent="0">
              <a:buNone/>
              <a:defRPr sz="1200"/>
            </a:lvl3pPr>
            <a:lvl4pPr marL="1371635" indent="0">
              <a:buNone/>
              <a:defRPr sz="1001"/>
            </a:lvl4pPr>
            <a:lvl5pPr marL="1828846" indent="0">
              <a:buNone/>
              <a:defRPr sz="1001"/>
            </a:lvl5pPr>
            <a:lvl6pPr marL="2286057" indent="0">
              <a:buNone/>
              <a:defRPr sz="1001"/>
            </a:lvl6pPr>
            <a:lvl7pPr marL="2743268" indent="0">
              <a:buNone/>
              <a:defRPr sz="1001"/>
            </a:lvl7pPr>
            <a:lvl8pPr marL="3200481" indent="0">
              <a:buNone/>
              <a:defRPr sz="1001"/>
            </a:lvl8pPr>
            <a:lvl9pPr marL="3657692" indent="0">
              <a:buNone/>
              <a:defRPr sz="100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6D4BB94-2ECF-DB50-79AE-2E9F6D9EA5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0B823C-C00A-44F4-9664-6E4112EDF4BF}" type="datetimeFigureOut">
              <a:rPr kumimoji="1" lang="ja-JP" altLang="en-US" smtClean="0"/>
              <a:t>2025/1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7A99EFA-78C0-2F7E-1773-505F4BC6FE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B5BE47F-07E7-9FFB-12DF-912D9646B8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254EE4-857C-495E-ACE1-2787790E99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239841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A62E622B-AA15-6C67-1B8A-B5FA6B02B6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4" y="36512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73F3006-14DC-9496-545C-A6E3DC9FC59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4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6C63000-F65A-8FAF-E27C-01C30A2CAF7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1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0B823C-C00A-44F4-9664-6E4112EDF4BF}" type="datetimeFigureOut">
              <a:rPr kumimoji="1" lang="ja-JP" altLang="en-US" smtClean="0"/>
              <a:t>2025/1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ECDD121-D8C3-5A03-36C1-E19E02D6B11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4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957069E-60BF-5A6F-6297-7BA89CF2B81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1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254EE4-857C-495E-ACE1-2787790E99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71837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22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7" indent="-228607" algn="l" defTabSz="914422" rtl="0" eaLnBrk="1" latinLnBrk="0" hangingPunct="1">
        <a:lnSpc>
          <a:spcPct val="90000"/>
        </a:lnSpc>
        <a:spcBef>
          <a:spcPts val="1001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18" indent="-228607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29" indent="-228607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40" indent="-228607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2057453" indent="-228607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514664" indent="-228607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971875" indent="-228607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429086" indent="-228607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886297" indent="-228607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22" rtl="0" eaLnBrk="1" latinLnBrk="0" hangingPunct="1">
        <a:defRPr kumimoji="1" sz="1801" kern="1200">
          <a:solidFill>
            <a:schemeClr val="tx1"/>
          </a:solidFill>
          <a:latin typeface="+mn-lt"/>
          <a:ea typeface="+mn-ea"/>
          <a:cs typeface="+mn-cs"/>
        </a:defRPr>
      </a:lvl1pPr>
      <a:lvl2pPr marL="457211" algn="l" defTabSz="914422" rtl="0" eaLnBrk="1" latinLnBrk="0" hangingPunct="1">
        <a:defRPr kumimoji="1" sz="1801" kern="1200">
          <a:solidFill>
            <a:schemeClr val="tx1"/>
          </a:solidFill>
          <a:latin typeface="+mn-lt"/>
          <a:ea typeface="+mn-ea"/>
          <a:cs typeface="+mn-cs"/>
        </a:defRPr>
      </a:lvl2pPr>
      <a:lvl3pPr marL="914422" algn="l" defTabSz="914422" rtl="0" eaLnBrk="1" latinLnBrk="0" hangingPunct="1">
        <a:defRPr kumimoji="1" sz="1801" kern="1200">
          <a:solidFill>
            <a:schemeClr val="tx1"/>
          </a:solidFill>
          <a:latin typeface="+mn-lt"/>
          <a:ea typeface="+mn-ea"/>
          <a:cs typeface="+mn-cs"/>
        </a:defRPr>
      </a:lvl3pPr>
      <a:lvl4pPr marL="1371635" algn="l" defTabSz="914422" rtl="0" eaLnBrk="1" latinLnBrk="0" hangingPunct="1">
        <a:defRPr kumimoji="1"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1828846" algn="l" defTabSz="914422" rtl="0" eaLnBrk="1" latinLnBrk="0" hangingPunct="1">
        <a:defRPr kumimoji="1"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286057" algn="l" defTabSz="914422" rtl="0" eaLnBrk="1" latinLnBrk="0" hangingPunct="1">
        <a:defRPr kumimoji="1"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743268" algn="l" defTabSz="914422" rtl="0" eaLnBrk="1" latinLnBrk="0" hangingPunct="1">
        <a:defRPr kumimoji="1"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200481" algn="l" defTabSz="914422" rtl="0" eaLnBrk="1" latinLnBrk="0" hangingPunct="1">
        <a:defRPr kumimoji="1"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657692" algn="l" defTabSz="914422" rtl="0" eaLnBrk="1" latinLnBrk="0" hangingPunct="1">
        <a:defRPr kumimoji="1" sz="18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タイトル 2">
            <a:extLst>
              <a:ext uri="{FF2B5EF4-FFF2-40B4-BE49-F238E27FC236}">
                <a16:creationId xmlns:a16="http://schemas.microsoft.com/office/drawing/2014/main" id="{B06D82D9-AC6E-A611-9FA1-72DD53D549FD}"/>
              </a:ext>
            </a:extLst>
          </p:cNvPr>
          <p:cNvSpPr txBox="1">
            <a:spLocks/>
          </p:cNvSpPr>
          <p:nvPr/>
        </p:nvSpPr>
        <p:spPr>
          <a:xfrm>
            <a:off x="221220" y="133092"/>
            <a:ext cx="2733735" cy="477470"/>
          </a:xfrm>
          <a:prstGeom prst="rect">
            <a:avLst/>
          </a:prstGeom>
        </p:spPr>
        <p:txBody>
          <a:bodyPr vert="horz" lIns="91440" tIns="45721" rIns="91440" bIns="45721" rtlCol="0" anchor="ctr">
            <a:normAutofit fontScale="70000" lnSpcReduction="200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800" dirty="0"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upplementary Figure 1</a:t>
            </a:r>
            <a:endParaRPr lang="ja-JP" altLang="en-US" sz="2800" dirty="0"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pic>
        <p:nvPicPr>
          <p:cNvPr id="2" name="図 1" descr="室内 が含まれている画像&#10;&#10;自動的に生成された説明">
            <a:extLst>
              <a:ext uri="{FF2B5EF4-FFF2-40B4-BE49-F238E27FC236}">
                <a16:creationId xmlns:a16="http://schemas.microsoft.com/office/drawing/2014/main" id="{D9B090EE-E1FE-FD1F-6B67-05CCB819740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657" t="21946" r="7181" b="20469"/>
          <a:stretch/>
        </p:blipFill>
        <p:spPr>
          <a:xfrm>
            <a:off x="3025567" y="1174453"/>
            <a:ext cx="6175464" cy="4225319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B95876A0-573B-997D-9B64-DDF840E25B41}"/>
              </a:ext>
            </a:extLst>
          </p:cNvPr>
          <p:cNvSpPr txBox="1"/>
          <p:nvPr/>
        </p:nvSpPr>
        <p:spPr>
          <a:xfrm>
            <a:off x="1376414" y="5683546"/>
            <a:ext cx="971189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Total skeletal muscle volume (cm</a:t>
            </a:r>
            <a:r>
              <a:rPr lang="en-US" altLang="ja-JP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2</a:t>
            </a:r>
            <a:r>
              <a:rPr lang="en-US" altLang="ja-JP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) was measured at </a:t>
            </a:r>
            <a:r>
              <a:rPr lang="en-US" altLang="ja-JP" dirty="0">
                <a:effectLst/>
                <a:latin typeface="Times New Roman" panose="02020603050405020304" pitchFamily="18" charset="0"/>
                <a:ea typeface="PMingLiU" panose="02020500000000000000" pitchFamily="18" charset="-120"/>
              </a:rPr>
              <a:t>the cross-sectional area of </a:t>
            </a:r>
            <a:r>
              <a:rPr lang="en-US" altLang="ja-JP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the lower level of L3.  </a:t>
            </a:r>
          </a:p>
          <a:p>
            <a:r>
              <a:rPr lang="en-US" altLang="ja-JP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SMI (cm</a:t>
            </a:r>
            <a:r>
              <a:rPr lang="en-US" altLang="ja-JP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2</a:t>
            </a:r>
            <a:r>
              <a:rPr lang="en-US" altLang="ja-JP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/m</a:t>
            </a:r>
            <a:r>
              <a:rPr lang="en-US" altLang="ja-JP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2</a:t>
            </a:r>
            <a:r>
              <a:rPr lang="en-US" altLang="ja-JP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) was calculated using the following formula: total skeletal muscle volume  / height (m)</a:t>
            </a:r>
            <a:r>
              <a:rPr lang="en-US" altLang="ja-JP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2</a:t>
            </a:r>
            <a:r>
              <a:rPr lang="en-US" altLang="ja-JP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.</a:t>
            </a:r>
            <a:endParaRPr lang="ja-JP" altLang="en-US" sz="2800" dirty="0"/>
          </a:p>
        </p:txBody>
      </p:sp>
      <p:sp>
        <p:nvSpPr>
          <p:cNvPr id="6" name="タイトル 2">
            <a:extLst>
              <a:ext uri="{FF2B5EF4-FFF2-40B4-BE49-F238E27FC236}">
                <a16:creationId xmlns:a16="http://schemas.microsoft.com/office/drawing/2014/main" id="{78D74227-0D3B-7103-D41F-715E8B00DD4F}"/>
              </a:ext>
            </a:extLst>
          </p:cNvPr>
          <p:cNvSpPr txBox="1">
            <a:spLocks/>
          </p:cNvSpPr>
          <p:nvPr/>
        </p:nvSpPr>
        <p:spPr>
          <a:xfrm>
            <a:off x="3116981" y="371827"/>
            <a:ext cx="5958038" cy="477470"/>
          </a:xfrm>
          <a:prstGeom prst="rect">
            <a:avLst/>
          </a:prstGeom>
        </p:spPr>
        <p:txBody>
          <a:bodyPr vert="horz" lIns="91440" tIns="45721" rIns="91440" bIns="45721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400" dirty="0"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Measurement of Skeletal Muscle index (SMI)</a:t>
            </a:r>
            <a:endParaRPr lang="ja-JP" altLang="en-US" sz="2400" dirty="0"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94725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2">
            <a:extLst>
              <a:ext uri="{FF2B5EF4-FFF2-40B4-BE49-F238E27FC236}">
                <a16:creationId xmlns:a16="http://schemas.microsoft.com/office/drawing/2014/main" id="{29BECE84-9A19-FD52-68CB-9BFF130E0218}"/>
              </a:ext>
            </a:extLst>
          </p:cNvPr>
          <p:cNvSpPr txBox="1">
            <a:spLocks/>
          </p:cNvSpPr>
          <p:nvPr/>
        </p:nvSpPr>
        <p:spPr>
          <a:xfrm>
            <a:off x="247432" y="146332"/>
            <a:ext cx="2733735" cy="477470"/>
          </a:xfrm>
          <a:prstGeom prst="rect">
            <a:avLst/>
          </a:prstGeom>
        </p:spPr>
        <p:txBody>
          <a:bodyPr vert="horz" lIns="91440" tIns="45721" rIns="91440" bIns="45721" rtlCol="0" anchor="ctr">
            <a:normAutofit fontScale="70000" lnSpcReduction="200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800" dirty="0"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upplementary Figure 2</a:t>
            </a:r>
            <a:endParaRPr lang="ja-JP" altLang="en-US" sz="2800" dirty="0"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FD20838D-247C-6659-8D41-2DF399474217}"/>
              </a:ext>
            </a:extLst>
          </p:cNvPr>
          <p:cNvSpPr txBox="1"/>
          <p:nvPr/>
        </p:nvSpPr>
        <p:spPr>
          <a:xfrm>
            <a:off x="2421628" y="732873"/>
            <a:ext cx="746920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 between BMD and SMI before and after NAC</a:t>
            </a:r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471A604A-AB9B-3F34-BDE2-81D603BB5DC9}"/>
              </a:ext>
            </a:extLst>
          </p:cNvPr>
          <p:cNvSpPr txBox="1"/>
          <p:nvPr/>
        </p:nvSpPr>
        <p:spPr>
          <a:xfrm rot="5400000">
            <a:off x="10610" y="3863391"/>
            <a:ext cx="12849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BMD (HU) 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E0B4C00E-2A87-D8AB-BC7D-00E353ED5E03}"/>
              </a:ext>
            </a:extLst>
          </p:cNvPr>
          <p:cNvSpPr txBox="1"/>
          <p:nvPr/>
        </p:nvSpPr>
        <p:spPr>
          <a:xfrm>
            <a:off x="2421628" y="6088730"/>
            <a:ext cx="15923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MI (cm</a:t>
            </a:r>
            <a:r>
              <a:rPr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/m</a:t>
            </a:r>
            <a:r>
              <a:rPr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" name="図 10">
            <a:extLst>
              <a:ext uri="{FF2B5EF4-FFF2-40B4-BE49-F238E27FC236}">
                <a16:creationId xmlns:a16="http://schemas.microsoft.com/office/drawing/2014/main" id="{37E38CCD-F898-3EB3-724D-44C3ED7474F5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9083" t="8602" r="2219" b="11913"/>
          <a:stretch/>
        </p:blipFill>
        <p:spPr>
          <a:xfrm>
            <a:off x="963274" y="2068663"/>
            <a:ext cx="4545898" cy="3958790"/>
          </a:xfrm>
          <a:prstGeom prst="rect">
            <a:avLst/>
          </a:prstGeom>
        </p:spPr>
      </p:pic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629DCC98-D536-FACC-5014-B28BADC660E7}"/>
              </a:ext>
            </a:extLst>
          </p:cNvPr>
          <p:cNvSpPr txBox="1"/>
          <p:nvPr/>
        </p:nvSpPr>
        <p:spPr>
          <a:xfrm>
            <a:off x="3883154" y="2307556"/>
            <a:ext cx="1397286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earman rank</a:t>
            </a:r>
          </a:p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 = 0.22</a:t>
            </a:r>
          </a:p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= 0.02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025F26E7-0A25-914A-DED5-9F4266EBE017}"/>
              </a:ext>
            </a:extLst>
          </p:cNvPr>
          <p:cNvSpPr txBox="1"/>
          <p:nvPr/>
        </p:nvSpPr>
        <p:spPr>
          <a:xfrm>
            <a:off x="7936903" y="1584419"/>
            <a:ext cx="183434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fter NAC</a:t>
            </a:r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5" name="図 14">
            <a:extLst>
              <a:ext uri="{FF2B5EF4-FFF2-40B4-BE49-F238E27FC236}">
                <a16:creationId xmlns:a16="http://schemas.microsoft.com/office/drawing/2014/main" id="{3A6DC52B-2318-E96F-0C28-FAD02F6DF4F5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8740" t="7336" b="11508"/>
          <a:stretch/>
        </p:blipFill>
        <p:spPr>
          <a:xfrm>
            <a:off x="6486877" y="1984808"/>
            <a:ext cx="4545899" cy="4042645"/>
          </a:xfrm>
          <a:prstGeom prst="rect">
            <a:avLst/>
          </a:prstGeom>
        </p:spPr>
      </p:pic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0C0716CE-8F79-ED90-D786-9DC09550B5A9}"/>
              </a:ext>
            </a:extLst>
          </p:cNvPr>
          <p:cNvSpPr txBox="1"/>
          <p:nvPr/>
        </p:nvSpPr>
        <p:spPr>
          <a:xfrm>
            <a:off x="2420754" y="1587397"/>
            <a:ext cx="183434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efore</a:t>
            </a:r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AC</a:t>
            </a:r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F62C87DA-C2CD-BE63-E86D-272F207DC7BD}"/>
              </a:ext>
            </a:extLst>
          </p:cNvPr>
          <p:cNvSpPr txBox="1"/>
          <p:nvPr/>
        </p:nvSpPr>
        <p:spPr>
          <a:xfrm rot="5400000">
            <a:off x="5638172" y="3886829"/>
            <a:ext cx="12849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BMD (HU) 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A8660DB6-158E-3A13-81A3-95497A85F07C}"/>
              </a:ext>
            </a:extLst>
          </p:cNvPr>
          <p:cNvSpPr txBox="1"/>
          <p:nvPr/>
        </p:nvSpPr>
        <p:spPr>
          <a:xfrm>
            <a:off x="8057904" y="6088730"/>
            <a:ext cx="15923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MI (cm</a:t>
            </a:r>
            <a:r>
              <a:rPr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/m</a:t>
            </a:r>
            <a:r>
              <a:rPr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24562BAE-87DB-993A-7DE5-8C215ED2BD6C}"/>
              </a:ext>
            </a:extLst>
          </p:cNvPr>
          <p:cNvSpPr txBox="1"/>
          <p:nvPr/>
        </p:nvSpPr>
        <p:spPr>
          <a:xfrm>
            <a:off x="9290948" y="2307556"/>
            <a:ext cx="1397286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earman rank</a:t>
            </a:r>
          </a:p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 = 0.24</a:t>
            </a:r>
          </a:p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= 0.02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439706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297</TotalTime>
  <Words>108</Words>
  <Application>Microsoft Office PowerPoint</Application>
  <PresentationFormat>ワイド画面</PresentationFormat>
  <Paragraphs>19</Paragraphs>
  <Slides>2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佐藤 和秀</dc:creator>
  <cp:lastModifiedBy>慶太 髙橋</cp:lastModifiedBy>
  <cp:revision>42</cp:revision>
  <cp:lastPrinted>2023-03-28T09:04:05Z</cp:lastPrinted>
  <dcterms:created xsi:type="dcterms:W3CDTF">2022-11-27T22:01:48Z</dcterms:created>
  <dcterms:modified xsi:type="dcterms:W3CDTF">2025-01-03T04:27:53Z</dcterms:modified>
</cp:coreProperties>
</file>